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5" autoAdjust="0"/>
    <p:restoredTop sz="94660"/>
  </p:normalViewPr>
  <p:slideViewPr>
    <p:cSldViewPr snapToGrid="0">
      <p:cViewPr varScale="1">
        <p:scale>
          <a:sx n="85" d="100"/>
          <a:sy n="85" d="100"/>
        </p:scale>
        <p:origin x="9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 smtClean="0"/>
              <a:t>Clique para editar o estilo do subtítulo mestre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D8D5C-2EED-4C63-A05E-E27C20D5D095}" type="datetimeFigureOut">
              <a:rPr lang="pt-BR" smtClean="0"/>
              <a:t>18/11/2014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84C8F8-2730-4B16-B1F8-E4AB5E81B2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3252558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D8D5C-2EED-4C63-A05E-E27C20D5D095}" type="datetimeFigureOut">
              <a:rPr lang="pt-BR" smtClean="0"/>
              <a:t>18/11/2014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84C8F8-2730-4B16-B1F8-E4AB5E81B2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6455052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D8D5C-2EED-4C63-A05E-E27C20D5D095}" type="datetimeFigureOut">
              <a:rPr lang="pt-BR" smtClean="0"/>
              <a:t>18/11/2014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84C8F8-2730-4B16-B1F8-E4AB5E81B2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233073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D8D5C-2EED-4C63-A05E-E27C20D5D095}" type="datetimeFigureOut">
              <a:rPr lang="pt-BR" smtClean="0"/>
              <a:t>18/11/2014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84C8F8-2730-4B16-B1F8-E4AB5E81B2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4207136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D8D5C-2EED-4C63-A05E-E27C20D5D095}" type="datetimeFigureOut">
              <a:rPr lang="pt-BR" smtClean="0"/>
              <a:t>18/11/2014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84C8F8-2730-4B16-B1F8-E4AB5E81B2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3599860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D8D5C-2EED-4C63-A05E-E27C20D5D095}" type="datetimeFigureOut">
              <a:rPr lang="pt-BR" smtClean="0"/>
              <a:t>18/11/2014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84C8F8-2730-4B16-B1F8-E4AB5E81B2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323687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D8D5C-2EED-4C63-A05E-E27C20D5D095}" type="datetimeFigureOut">
              <a:rPr lang="pt-BR" smtClean="0"/>
              <a:t>18/11/2014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84C8F8-2730-4B16-B1F8-E4AB5E81B2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0106317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D8D5C-2EED-4C63-A05E-E27C20D5D095}" type="datetimeFigureOut">
              <a:rPr lang="pt-BR" smtClean="0"/>
              <a:t>18/11/2014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84C8F8-2730-4B16-B1F8-E4AB5E81B2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7155300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D8D5C-2EED-4C63-A05E-E27C20D5D095}" type="datetimeFigureOut">
              <a:rPr lang="pt-BR" smtClean="0"/>
              <a:t>18/11/2014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84C8F8-2730-4B16-B1F8-E4AB5E81B2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7452788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D8D5C-2EED-4C63-A05E-E27C20D5D095}" type="datetimeFigureOut">
              <a:rPr lang="pt-BR" smtClean="0"/>
              <a:t>18/11/2014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84C8F8-2730-4B16-B1F8-E4AB5E81B2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7920576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D8D5C-2EED-4C63-A05E-E27C20D5D095}" type="datetimeFigureOut">
              <a:rPr lang="pt-BR" smtClean="0"/>
              <a:t>18/11/2014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84C8F8-2730-4B16-B1F8-E4AB5E81B2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4035802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ED8D5C-2EED-4C63-A05E-E27C20D5D095}" type="datetimeFigureOut">
              <a:rPr lang="pt-BR" smtClean="0"/>
              <a:t>18/11/2014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84C8F8-2730-4B16-B1F8-E4AB5E81B2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6368222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0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158" r="68039" b="49630"/>
          <a:stretch/>
        </p:blipFill>
        <p:spPr bwMode="auto">
          <a:xfrm>
            <a:off x="1045648" y="816292"/>
            <a:ext cx="1520119" cy="15352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10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519" t="9775" r="34697" b="48060"/>
          <a:stretch/>
        </p:blipFill>
        <p:spPr bwMode="gray">
          <a:xfrm>
            <a:off x="3273640" y="917893"/>
            <a:ext cx="1519707" cy="16098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10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428" t="7075" r="3786" b="44687"/>
          <a:stretch/>
        </p:blipFill>
        <p:spPr bwMode="gray">
          <a:xfrm>
            <a:off x="5171430" y="859329"/>
            <a:ext cx="1416675" cy="184167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10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77" t="58349" r="66337"/>
          <a:stretch/>
        </p:blipFill>
        <p:spPr bwMode="gray">
          <a:xfrm>
            <a:off x="1321744" y="2864170"/>
            <a:ext cx="1416677" cy="16438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10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829" t="53626" r="31677"/>
          <a:stretch/>
        </p:blipFill>
        <p:spPr bwMode="gray">
          <a:xfrm>
            <a:off x="3334023" y="2769926"/>
            <a:ext cx="1545464" cy="17705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" name="CaixaDeTexto 9"/>
          <p:cNvSpPr txBox="1"/>
          <p:nvPr/>
        </p:nvSpPr>
        <p:spPr>
          <a:xfrm>
            <a:off x="1479634" y="686395"/>
            <a:ext cx="8358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pt-B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CaixaDeTexto 10"/>
          <p:cNvSpPr txBox="1"/>
          <p:nvPr/>
        </p:nvSpPr>
        <p:spPr>
          <a:xfrm>
            <a:off x="3490473" y="674535"/>
            <a:ext cx="11519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ycop</a:t>
            </a:r>
            <a:r>
              <a:rPr lang="pt-B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5µM</a:t>
            </a:r>
            <a:endParaRPr lang="pt-B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CaixaDeTexto 12"/>
          <p:cNvSpPr txBox="1"/>
          <p:nvPr/>
        </p:nvSpPr>
        <p:spPr>
          <a:xfrm>
            <a:off x="5315646" y="683917"/>
            <a:ext cx="13966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ycop</a:t>
            </a:r>
            <a:r>
              <a:rPr lang="pt-B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0µM</a:t>
            </a:r>
            <a:endParaRPr lang="pt-B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CaixaDeTexto 13"/>
          <p:cNvSpPr txBox="1"/>
          <p:nvPr/>
        </p:nvSpPr>
        <p:spPr>
          <a:xfrm>
            <a:off x="1357366" y="2657575"/>
            <a:ext cx="13147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pt-B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pt-BR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rot</a:t>
            </a:r>
            <a:r>
              <a:rPr lang="pt-B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5µM</a:t>
            </a:r>
            <a:endParaRPr lang="pt-B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CaixaDeTexto 14"/>
          <p:cNvSpPr txBox="1"/>
          <p:nvPr/>
        </p:nvSpPr>
        <p:spPr>
          <a:xfrm>
            <a:off x="3492069" y="2695061"/>
            <a:ext cx="14487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pt-B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pt-BR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rot</a:t>
            </a:r>
            <a:r>
              <a:rPr lang="pt-B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0µM</a:t>
            </a:r>
            <a:endParaRPr lang="pt-B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Retângulo 16"/>
          <p:cNvSpPr/>
          <p:nvPr/>
        </p:nvSpPr>
        <p:spPr>
          <a:xfrm>
            <a:off x="1277846" y="4477061"/>
            <a:ext cx="379307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ree independent experiments were performed. </a:t>
            </a:r>
            <a:endParaRPr lang="en-US" sz="1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se, we chose a representative to photograph.</a:t>
            </a:r>
            <a:endParaRPr lang="pt-B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CaixaDeTexto 8"/>
          <p:cNvSpPr txBox="1"/>
          <p:nvPr/>
        </p:nvSpPr>
        <p:spPr>
          <a:xfrm>
            <a:off x="10035821" y="6440635"/>
            <a:ext cx="19479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addad </a:t>
            </a:r>
            <a:r>
              <a:rPr lang="pt-BR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 al</a:t>
            </a:r>
            <a:r>
              <a:rPr lang="pt-B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 2013</a:t>
            </a:r>
            <a:endParaRPr lang="pt-B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CaixaDeTexto 11"/>
          <p:cNvSpPr txBox="1"/>
          <p:nvPr/>
        </p:nvSpPr>
        <p:spPr>
          <a:xfrm>
            <a:off x="4495667" y="6434665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pt-BR" dirty="0"/>
          </a:p>
        </p:txBody>
      </p:sp>
      <p:sp>
        <p:nvSpPr>
          <p:cNvPr id="18" name="CaixaDeTexto 17"/>
          <p:cNvSpPr txBox="1"/>
          <p:nvPr/>
        </p:nvSpPr>
        <p:spPr>
          <a:xfrm>
            <a:off x="1357366" y="5301813"/>
            <a:ext cx="1012343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. Formation of AtT-20 colonies. The number of AtT-20 colonies was determined after 21 days of culture in DMEM supplemente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 10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% FCS containing lycopene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yco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beta-carotene (beta-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ro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t concentrations of 5 and 10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number of colonies formed wa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tected by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ystal violet staining. Phase contrast microscopy of AtT-20 cell colonies was observed on 6-well culture plates (A) and quantitativ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on of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olonies formed (B). Data are presented a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an + standar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viation of 3 independent experiments, each performed at least in duplicate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*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icates significant differences from control group (**p,0.01, ***p,0.001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pt-B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oi:10.1371/journal.pone.0062773.g002</a:t>
            </a:r>
            <a:endParaRPr lang="pt-B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CaixaDeTexto 20"/>
          <p:cNvSpPr txBox="1"/>
          <p:nvPr/>
        </p:nvSpPr>
        <p:spPr>
          <a:xfrm>
            <a:off x="1045648" y="-37864"/>
            <a:ext cx="1068350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2: CFU </a:t>
            </a:r>
            <a:r>
              <a:rPr lang="pt-BR" sz="2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pt-B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tT20 </a:t>
            </a:r>
            <a:r>
              <a:rPr lang="pt-BR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pt-B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BR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ated</a:t>
            </a:r>
            <a:r>
              <a:rPr lang="pt-B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BR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pt-B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BR" sz="2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ycopene</a:t>
            </a:r>
            <a:r>
              <a:rPr lang="pt-B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BR" sz="2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pt-B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l-G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pt-B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pt-BR" sz="2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rotene</a:t>
            </a:r>
            <a:endParaRPr lang="pt-BR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pt-BR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Raw data</a:t>
            </a:r>
            <a:r>
              <a:rPr lang="pt-B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pt-BR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9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49757983"/>
              </p:ext>
            </p:extLst>
          </p:nvPr>
        </p:nvGraphicFramePr>
        <p:xfrm>
          <a:off x="7292652" y="1683352"/>
          <a:ext cx="4382272" cy="263897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Project" r:id="rId4" imgW="6516000" imgH="3924000" progId="Prism5.Document">
                  <p:embed/>
                </p:oleObj>
              </mc:Choice>
              <mc:Fallback>
                <p:oleObj name="Prism Project" r:id="rId4" imgW="6516000" imgH="3924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292652" y="1683352"/>
                        <a:ext cx="4382272" cy="263897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" name="Retângulo 19"/>
          <p:cNvSpPr/>
          <p:nvPr/>
        </p:nvSpPr>
        <p:spPr>
          <a:xfrm>
            <a:off x="6503671" y="4280757"/>
            <a:ext cx="5688330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aphic exported directly from the Graph Prism 5.0 program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is file provides access to the raw values.</a:t>
            </a:r>
            <a:endParaRPr lang="pt-BR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0959376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Escritório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4</TotalTime>
  <Words>184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8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Servidores OLE inseridos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o Office</vt:lpstr>
      <vt:lpstr>GraphPad Prism 5 Project</vt:lpstr>
      <vt:lpstr>Apresentação do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Natália Haddad</dc:creator>
  <cp:lastModifiedBy>Natália Haddad</cp:lastModifiedBy>
  <cp:revision>19</cp:revision>
  <dcterms:created xsi:type="dcterms:W3CDTF">2014-11-13T19:04:58Z</dcterms:created>
  <dcterms:modified xsi:type="dcterms:W3CDTF">2014-11-18T17:36:53Z</dcterms:modified>
</cp:coreProperties>
</file>